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1776" y="-5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OneDrive\&#26700;&#38754;\&#23450;&#37327;&#32467;&#26524;\&#23450;&#37327;&#32467;&#26524;&#27719;&#24635;\20220616\20220616&#20869;&#21442;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OneDrive\&#26700;&#38754;\&#23450;&#37327;&#32467;&#26524;\&#23450;&#37327;&#32467;&#26524;&#27719;&#24635;\20220616\20220616&#20869;&#21442;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OneDrive\&#26700;&#38754;\&#23450;&#37327;&#32467;&#26524;\&#23450;&#37327;&#32467;&#26524;&#27719;&#24635;\20220616\20220616&#20869;&#21442;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OneDrive\&#26700;&#38754;\&#23450;&#37327;&#32467;&#26524;\&#23450;&#37327;&#32467;&#26524;&#27719;&#24635;\20220616\20220616&#20869;&#21442;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OneDrive\&#26700;&#38754;\&#23450;&#37327;&#32467;&#26524;\&#23450;&#37327;&#32467;&#26524;&#27719;&#24635;\20220616\20220616&#20869;&#21442;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16722339640741"/>
          <c:y val="0.14249223051935631"/>
          <c:w val="0.82336997624051467"/>
          <c:h val="0.807027721008693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ene13!$A$1</c:f>
              <c:strCache>
                <c:ptCount val="1"/>
                <c:pt idx="0">
                  <c:v>AFS1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31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D05C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948-4488-98A8-0C472D53A1E3}"/>
              </c:ext>
            </c:extLst>
          </c:dPt>
          <c:dPt>
            <c:idx val="1"/>
            <c:invertIfNegative val="0"/>
            <c:bubble3D val="0"/>
            <c:spPr>
              <a:solidFill>
                <a:srgbClr val="EF3B6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948-4488-98A8-0C472D53A1E3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8EAA4A04-DC09-46AF-AFE7-5CF2FE182802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9948-4488-98A8-0C472D53A1E3}"/>
                </c:ext>
              </c:extLst>
            </c:dLbl>
            <c:dLbl>
              <c:idx val="1"/>
              <c:layout>
                <c:manualLayout>
                  <c:x val="-9.3133680555555556E-3"/>
                  <c:y val="9.0522787101806418E-2"/>
                </c:manualLayout>
              </c:layout>
              <c:tx>
                <c:rich>
                  <a:bodyPr rot="0" spcFirstLastPara="1" vertOverflow="ellipsis" vert="horz" wrap="square" lIns="0" tIns="0" rIns="0" bIns="0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14BFC465-9221-4FEE-9E7A-1EBCDD509E6C}" type="CELLRANGE">
                      <a:rPr lang="en-US" altLang="zh-CN"/>
                      <a:pPr>
                        <a:defRPr/>
                      </a:pPr>
                      <a:t>[CELLRANGE]</a:t>
                    </a:fld>
                    <a:endParaRPr lang="zh-CN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0" tIns="0" rIns="0" bIns="0" anchor="ctr" anchorCtr="1"/>
                <a:lstStyle/>
                <a:p>
                  <a:pPr>
                    <a:defRPr sz="8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zh-CN"/>
                </a:p>
              </c:tx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7511755039318264"/>
                      <c:h val="0.21075509131006104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9948-4488-98A8-0C472D53A1E3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981243CA-7E9B-40D3-B012-E9F76D1D7697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9948-4488-98A8-0C472D53A1E3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675F9179-E101-441D-879F-FAF415EE3130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9948-4488-98A8-0C472D53A1E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ene13!$R$3:$R$4</c:f>
                <c:numCache>
                  <c:formatCode>General</c:formatCode>
                  <c:ptCount val="2"/>
                  <c:pt idx="0">
                    <c:v>2.9041997813492218E-2</c:v>
                  </c:pt>
                  <c:pt idx="1">
                    <c:v>0.29667383198615699</c:v>
                  </c:pt>
                </c:numCache>
              </c:numRef>
            </c:plus>
            <c:minus>
              <c:numRef>
                <c:f>gene13!$R$3:$R$4</c:f>
                <c:numCache>
                  <c:formatCode>General</c:formatCode>
                  <c:ptCount val="2"/>
                  <c:pt idx="0">
                    <c:v>2.9041997813492218E-2</c:v>
                  </c:pt>
                  <c:pt idx="1">
                    <c:v>0.296673831986156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ene13!$P$3:$P$4</c:f>
              <c:strCache>
                <c:ptCount val="2"/>
                <c:pt idx="0">
                  <c:v>13-F1      </c:v>
                </c:pt>
                <c:pt idx="1">
                  <c:v>13-Y2      </c:v>
                </c:pt>
              </c:strCache>
            </c:strRef>
          </c:cat>
          <c:val>
            <c:numRef>
              <c:f>gene13!$Q$3:$Q$4</c:f>
              <c:numCache>
                <c:formatCode>General</c:formatCode>
                <c:ptCount val="2"/>
                <c:pt idx="0">
                  <c:v>1.0002787656162877</c:v>
                </c:pt>
                <c:pt idx="1">
                  <c:v>8.5973916326844151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2]root（模板）'!$S$10:$S$11</c15:f>
                <c15:dlblRangeCache>
                  <c:ptCount val="2"/>
                  <c:pt idx="1">
                    <c:v>**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6-9948-4488-98A8-0C472D53A1E3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-481308512"/>
        <c:axId val="-355665552"/>
      </c:barChart>
      <c:catAx>
        <c:axId val="-481308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355665552"/>
        <c:crosses val="autoZero"/>
        <c:auto val="1"/>
        <c:lblAlgn val="ctr"/>
        <c:lblOffset val="100"/>
        <c:noMultiLvlLbl val="0"/>
      </c:catAx>
      <c:valAx>
        <c:axId val="-355665552"/>
        <c:scaling>
          <c:orientation val="minMax"/>
          <c:max val="1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481308512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16722339640741"/>
          <c:y val="0.14249223051935631"/>
          <c:w val="0.82336997624051467"/>
          <c:h val="0.807027721008693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ene7!$A$1</c:f>
              <c:strCache>
                <c:ptCount val="1"/>
                <c:pt idx="0">
                  <c:v>DX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31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D05C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B66-425B-901A-74575FAA55AA}"/>
              </c:ext>
            </c:extLst>
          </c:dPt>
          <c:dPt>
            <c:idx val="1"/>
            <c:invertIfNegative val="0"/>
            <c:bubble3D val="0"/>
            <c:spPr>
              <a:solidFill>
                <a:srgbClr val="EF3B6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B66-425B-901A-74575FAA55AA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1E6CE3AD-DDB9-4B17-8BAB-D6DD61AE91E3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1B66-425B-901A-74575FAA55AA}"/>
                </c:ext>
              </c:extLst>
            </c:dLbl>
            <c:dLbl>
              <c:idx val="1"/>
              <c:layout>
                <c:manualLayout>
                  <c:x val="-9.3134715703664175E-3"/>
                  <c:y val="-1.8733714281344585E-2"/>
                </c:manualLayout>
              </c:layout>
              <c:tx>
                <c:rich>
                  <a:bodyPr rot="0" spcFirstLastPara="1" vertOverflow="ellipsis" vert="horz" wrap="square" lIns="0" tIns="0" rIns="0" bIns="0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BD7B165C-9CFE-4E27-AE8C-87724B9D772E}" type="CELLRANGE">
                      <a:rPr lang="en-US" altLang="zh-CN"/>
                      <a:pPr>
                        <a:defRPr/>
                      </a:pPr>
                      <a:t>[CELLRANGE]</a:t>
                    </a:fld>
                    <a:endParaRPr lang="zh-CN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0" tIns="0" rIns="0" bIns="0" anchor="ctr" anchorCtr="1"/>
                <a:lstStyle/>
                <a:p>
                  <a:pPr>
                    <a:defRPr sz="8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zh-CN"/>
                </a:p>
              </c:tx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7511755039318264"/>
                      <c:h val="0.21075509131006104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1B66-425B-901A-74575FAA55AA}"/>
                </c:ext>
              </c:extLst>
            </c:dLbl>
            <c:dLbl>
              <c:idx val="2"/>
              <c:layout>
                <c:manualLayout>
                  <c:x val="-5.4685016223404367E-17"/>
                  <c:y val="6.7796670489497196E-2"/>
                </c:manualLayout>
              </c:layout>
              <c:tx>
                <c:rich>
                  <a:bodyPr/>
                  <a:lstStyle/>
                  <a:p>
                    <a:fld id="{BAA24DD0-3F48-4B2F-98FD-AD0D07D4ED9F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1B66-425B-901A-74575FAA55AA}"/>
                </c:ext>
              </c:extLst>
            </c:dLbl>
            <c:dLbl>
              <c:idx val="3"/>
              <c:layout>
                <c:manualLayout>
                  <c:x val="0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981243CA-7E9B-40D3-B012-E9F76D1D7697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1B66-425B-901A-74575FAA55AA}"/>
                </c:ext>
              </c:extLst>
            </c:dLbl>
            <c:dLbl>
              <c:idx val="4"/>
              <c:layout>
                <c:manualLayout>
                  <c:x val="-1.0937003244680873E-16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675F9179-E101-441D-879F-FAF415EE3130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1B66-425B-901A-74575FAA55A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ene7!$R$3:$R$4</c:f>
                <c:numCache>
                  <c:formatCode>General</c:formatCode>
                  <c:ptCount val="2"/>
                  <c:pt idx="0">
                    <c:v>0.21354508475683165</c:v>
                  </c:pt>
                  <c:pt idx="1">
                    <c:v>1.3650905624298761</c:v>
                  </c:pt>
                </c:numCache>
              </c:numRef>
            </c:plus>
            <c:minus>
              <c:numRef>
                <c:f>gene7!$R$3:$R$4</c:f>
                <c:numCache>
                  <c:formatCode>General</c:formatCode>
                  <c:ptCount val="2"/>
                  <c:pt idx="0">
                    <c:v>0.21354508475683165</c:v>
                  </c:pt>
                  <c:pt idx="1">
                    <c:v>1.36509056242987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ene7!$P$3:$P$4</c:f>
              <c:strCache>
                <c:ptCount val="2"/>
                <c:pt idx="0">
                  <c:v>7-F1      </c:v>
                </c:pt>
                <c:pt idx="1">
                  <c:v>7-Y2      </c:v>
                </c:pt>
              </c:strCache>
            </c:strRef>
          </c:cat>
          <c:val>
            <c:numRef>
              <c:f>gene7!$Q$3:$Q$4</c:f>
              <c:numCache>
                <c:formatCode>General</c:formatCode>
                <c:ptCount val="2"/>
                <c:pt idx="0">
                  <c:v>1.0142592986289929</c:v>
                </c:pt>
                <c:pt idx="1">
                  <c:v>6.7531013783768179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C:\Users\admin\OneDrive\桌面\定量结果\数据整理模板\志萍师姐\[TSS- 2个样-模板.xlsx]root（模板）'!$S$10:$S$11</c15:f>
                <c15:dlblRangeCache>
                  <c:ptCount val="2"/>
                  <c:pt idx="1">
                    <c:v>**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7-1B66-425B-901A-74575FAA55A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-481308512"/>
        <c:axId val="-355665552"/>
      </c:barChart>
      <c:catAx>
        <c:axId val="-481308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355665552"/>
        <c:crosses val="autoZero"/>
        <c:auto val="1"/>
        <c:lblAlgn val="ctr"/>
        <c:lblOffset val="100"/>
        <c:noMultiLvlLbl val="0"/>
      </c:catAx>
      <c:valAx>
        <c:axId val="-355665552"/>
        <c:scaling>
          <c:orientation val="minMax"/>
          <c:max val="9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481308512"/>
        <c:crosses val="autoZero"/>
        <c:crossBetween val="between"/>
        <c:majorUnit val="3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16722339640741"/>
          <c:y val="0.14249223051935631"/>
          <c:w val="0.82336997624051467"/>
          <c:h val="0.807027721008693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ene9(下)'!$A$1</c:f>
              <c:strCache>
                <c:ptCount val="1"/>
                <c:pt idx="0">
                  <c:v>DXR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31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D05C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F2C-4DF4-B598-D3B7752D5896}"/>
              </c:ext>
            </c:extLst>
          </c:dPt>
          <c:dPt>
            <c:idx val="1"/>
            <c:invertIfNegative val="0"/>
            <c:bubble3D val="0"/>
            <c:spPr>
              <a:solidFill>
                <a:srgbClr val="EF3B6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F2C-4DF4-B598-D3B7752D5896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0C6C8BBB-996A-41D1-AAED-64B410222055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3F2C-4DF4-B598-D3B7752D5896}"/>
                </c:ext>
              </c:extLst>
            </c:dLbl>
            <c:dLbl>
              <c:idx val="1"/>
              <c:layout>
                <c:manualLayout>
                  <c:x val="-9.3134715703664175E-3"/>
                  <c:y val="-3.2449236305290952E-2"/>
                </c:manualLayout>
              </c:layout>
              <c:tx>
                <c:rich>
                  <a:bodyPr rot="0" spcFirstLastPara="1" vertOverflow="ellipsis" vert="horz" wrap="square" lIns="0" tIns="0" rIns="0" bIns="0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919D964F-3997-4FE0-B6DD-44C6F1BD0995}" type="CELLREF">
                      <a:rPr lang="en-US" altLang="zh-CN"/>
                      <a:pPr>
                        <a:defRPr/>
                      </a:pPr>
                      <a:t>[CELLREF]</a:t>
                    </a:fld>
                    <a:endParaRPr lang="zh-CN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0" tIns="0" rIns="0" bIns="0" anchor="ctr" anchorCtr="1"/>
                <a:lstStyle/>
                <a:p>
                  <a:pPr>
                    <a:defRPr sz="8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zh-CN"/>
                </a:p>
              </c:tx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7511755039318264"/>
                      <c:h val="0.21075509131006104"/>
                    </c:manualLayout>
                  </c15:layout>
                  <c15:dlblFieldTable>
                    <c15:dlblFTEntry>
                      <c15:txfldGUID>{919D964F-3997-4FE0-B6DD-44C6F1BD0995}</c15:txfldGUID>
                      <c15:f>'gene9(下)'!$S$11</c15:f>
                      <c15:dlblFieldTableCache>
                        <c:ptCount val="1"/>
                      </c15:dlblFieldTableCache>
                    </c15:dlblFTEntry>
                  </c15:dlblFieldTable>
                  <c15:showDataLabelsRange val="1"/>
                </c:ext>
                <c:ext xmlns:c16="http://schemas.microsoft.com/office/drawing/2014/chart" uri="{C3380CC4-5D6E-409C-BE32-E72D297353CC}">
                  <c16:uniqueId val="{00000003-3F2C-4DF4-B598-D3B7752D5896}"/>
                </c:ext>
              </c:extLst>
            </c:dLbl>
            <c:dLbl>
              <c:idx val="2"/>
              <c:layout>
                <c:manualLayout>
                  <c:x val="-5.4685016223404367E-17"/>
                  <c:y val="6.7796670489497196E-2"/>
                </c:manualLayout>
              </c:layout>
              <c:tx>
                <c:rich>
                  <a:bodyPr/>
                  <a:lstStyle/>
                  <a:p>
                    <a:fld id="{BAA24DD0-3F48-4B2F-98FD-AD0D07D4ED9F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3F2C-4DF4-B598-D3B7752D5896}"/>
                </c:ext>
              </c:extLst>
            </c:dLbl>
            <c:dLbl>
              <c:idx val="3"/>
              <c:layout>
                <c:manualLayout>
                  <c:x val="0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981243CA-7E9B-40D3-B012-E9F76D1D7697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3F2C-4DF4-B598-D3B7752D5896}"/>
                </c:ext>
              </c:extLst>
            </c:dLbl>
            <c:dLbl>
              <c:idx val="4"/>
              <c:layout>
                <c:manualLayout>
                  <c:x val="-1.0937003244680873E-16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675F9179-E101-441D-879F-FAF415EE3130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3F2C-4DF4-B598-D3B7752D589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gene9(下)'!$R$3:$R$4</c:f>
                <c:numCache>
                  <c:formatCode>General</c:formatCode>
                  <c:ptCount val="2"/>
                  <c:pt idx="0">
                    <c:v>8.3108964386977693E-2</c:v>
                  </c:pt>
                  <c:pt idx="1">
                    <c:v>0.21184760615949685</c:v>
                  </c:pt>
                </c:numCache>
              </c:numRef>
            </c:plus>
            <c:minus>
              <c:numRef>
                <c:f>'gene9(下)'!$R$3:$R$4</c:f>
                <c:numCache>
                  <c:formatCode>General</c:formatCode>
                  <c:ptCount val="2"/>
                  <c:pt idx="0">
                    <c:v>8.3108964386977693E-2</c:v>
                  </c:pt>
                  <c:pt idx="1">
                    <c:v>0.211847606159496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gene9(下)'!$P$3:$P$4</c:f>
              <c:strCache>
                <c:ptCount val="2"/>
                <c:pt idx="0">
                  <c:v>9-F1       </c:v>
                </c:pt>
                <c:pt idx="1">
                  <c:v>9-Y2       </c:v>
                </c:pt>
              </c:strCache>
            </c:strRef>
          </c:cat>
          <c:val>
            <c:numRef>
              <c:f>'gene9(下)'!$Q$3:$Q$4</c:f>
              <c:numCache>
                <c:formatCode>General</c:formatCode>
                <c:ptCount val="2"/>
                <c:pt idx="0">
                  <c:v>1.0023182525207426</c:v>
                </c:pt>
                <c:pt idx="1">
                  <c:v>0.78419746856621775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2]root（模板）'!$S$10:$S$11</c15:f>
                <c15:dlblRangeCache>
                  <c:ptCount val="2"/>
                  <c:pt idx="1">
                    <c:v>**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7-3F2C-4DF4-B598-D3B7752D5896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-481308512"/>
        <c:axId val="-355665552"/>
      </c:barChart>
      <c:catAx>
        <c:axId val="-481308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355665552"/>
        <c:crosses val="autoZero"/>
        <c:auto val="1"/>
        <c:lblAlgn val="ctr"/>
        <c:lblOffset val="100"/>
        <c:noMultiLvlLbl val="0"/>
      </c:catAx>
      <c:valAx>
        <c:axId val="-355665552"/>
        <c:scaling>
          <c:orientation val="minMax"/>
          <c:max val="2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481308512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290104166666669"/>
          <c:y val="0.13873855100835245"/>
          <c:w val="0.82336997624051467"/>
          <c:h val="0.807027721008693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ene15!$A$1</c:f>
              <c:strCache>
                <c:ptCount val="1"/>
                <c:pt idx="0">
                  <c:v>GGP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31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D05C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506-44B3-87FA-E834B2F91B14}"/>
              </c:ext>
            </c:extLst>
          </c:dPt>
          <c:dPt>
            <c:idx val="1"/>
            <c:invertIfNegative val="0"/>
            <c:bubble3D val="0"/>
            <c:spPr>
              <a:solidFill>
                <a:srgbClr val="EF3B6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506-44B3-87FA-E834B2F91B14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C8FF5BE0-F76B-444E-BA99-FBB4D23210F8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A506-44B3-87FA-E834B2F91B14}"/>
                </c:ext>
              </c:extLst>
            </c:dLbl>
            <c:dLbl>
              <c:idx val="1"/>
              <c:layout>
                <c:manualLayout>
                  <c:x val="-9.3124999999999996E-3"/>
                  <c:y val="5.4629206566478232E-2"/>
                </c:manualLayout>
              </c:layout>
              <c:tx>
                <c:rich>
                  <a:bodyPr rot="0" spcFirstLastPara="1" vertOverflow="ellipsis" vert="horz" wrap="square" lIns="0" tIns="0" rIns="0" bIns="0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F67BCD3A-2D78-462A-A37B-E35018F37EF3}" type="CELLRANGE">
                      <a:rPr lang="en-US" altLang="zh-CN"/>
                      <a:pPr>
                        <a:defRPr/>
                      </a:pPr>
                      <a:t>[CELLRANGE]</a:t>
                    </a:fld>
                    <a:endParaRPr lang="zh-CN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0" tIns="0" rIns="0" bIns="0" anchor="ctr" anchorCtr="1"/>
                <a:lstStyle/>
                <a:p>
                  <a:pPr>
                    <a:defRPr sz="8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zh-CN"/>
                </a:p>
              </c:tx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7511805555555557"/>
                      <c:h val="0.22289473332046089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A506-44B3-87FA-E834B2F91B14}"/>
                </c:ext>
              </c:extLst>
            </c:dLbl>
            <c:dLbl>
              <c:idx val="2"/>
              <c:layout>
                <c:manualLayout>
                  <c:x val="-5.4685016223404367E-17"/>
                  <c:y val="6.7796670489497196E-2"/>
                </c:manualLayout>
              </c:layout>
              <c:tx>
                <c:rich>
                  <a:bodyPr/>
                  <a:lstStyle/>
                  <a:p>
                    <a:fld id="{BAA24DD0-3F48-4B2F-98FD-AD0D07D4ED9F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A506-44B3-87FA-E834B2F91B14}"/>
                </c:ext>
              </c:extLst>
            </c:dLbl>
            <c:dLbl>
              <c:idx val="3"/>
              <c:layout>
                <c:manualLayout>
                  <c:x val="0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981243CA-7E9B-40D3-B012-E9F76D1D7697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A506-44B3-87FA-E834B2F91B14}"/>
                </c:ext>
              </c:extLst>
            </c:dLbl>
            <c:dLbl>
              <c:idx val="4"/>
              <c:layout>
                <c:manualLayout>
                  <c:x val="-1.0937003244680873E-16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675F9179-E101-441D-879F-FAF415EE3130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A506-44B3-87FA-E834B2F91B1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ene15!$R$3:$R$4</c:f>
                <c:numCache>
                  <c:formatCode>General</c:formatCode>
                  <c:ptCount val="2"/>
                  <c:pt idx="0">
                    <c:v>0.24299075717983293</c:v>
                  </c:pt>
                  <c:pt idx="1">
                    <c:v>0.62885680955150225</c:v>
                  </c:pt>
                </c:numCache>
              </c:numRef>
            </c:plus>
            <c:minus>
              <c:numRef>
                <c:f>gene15!$R$3:$R$4</c:f>
                <c:numCache>
                  <c:formatCode>General</c:formatCode>
                  <c:ptCount val="2"/>
                  <c:pt idx="0">
                    <c:v>0.24299075717983293</c:v>
                  </c:pt>
                  <c:pt idx="1">
                    <c:v>0.628856809551502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ene15!$P$3:$P$4</c:f>
              <c:strCache>
                <c:ptCount val="2"/>
                <c:pt idx="0">
                  <c:v>15-F1      </c:v>
                </c:pt>
                <c:pt idx="1">
                  <c:v>15-Y2      </c:v>
                </c:pt>
              </c:strCache>
            </c:strRef>
          </c:cat>
          <c:val>
            <c:numRef>
              <c:f>gene15!$Q$3:$Q$4</c:f>
              <c:numCache>
                <c:formatCode>General</c:formatCode>
                <c:ptCount val="2"/>
                <c:pt idx="0">
                  <c:v>1.0182351226629136</c:v>
                </c:pt>
                <c:pt idx="1">
                  <c:v>7.9065724194574605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2]root（模板）'!$S$10:$S$11</c15:f>
                <c15:dlblRangeCache>
                  <c:ptCount val="2"/>
                  <c:pt idx="1">
                    <c:v>**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7-A506-44B3-87FA-E834B2F91B1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-481308512"/>
        <c:axId val="-355665552"/>
      </c:barChart>
      <c:catAx>
        <c:axId val="-481308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355665552"/>
        <c:crosses val="autoZero"/>
        <c:auto val="1"/>
        <c:lblAlgn val="ctr"/>
        <c:lblOffset val="100"/>
        <c:noMultiLvlLbl val="0"/>
      </c:catAx>
      <c:valAx>
        <c:axId val="-355665552"/>
        <c:scaling>
          <c:orientation val="minMax"/>
          <c:max val="9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481308512"/>
        <c:crosses val="autoZero"/>
        <c:crossBetween val="between"/>
        <c:majorUnit val="3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16722339640741"/>
          <c:y val="0.14249223051935631"/>
          <c:w val="0.82336997624051467"/>
          <c:h val="0.807027721008693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ene21!$A$1</c:f>
              <c:strCache>
                <c:ptCount val="1"/>
                <c:pt idx="0">
                  <c:v>HMGC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31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D05C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BA9-412F-83FC-F406CBEAE29D}"/>
              </c:ext>
            </c:extLst>
          </c:dPt>
          <c:dPt>
            <c:idx val="1"/>
            <c:invertIfNegative val="0"/>
            <c:bubble3D val="0"/>
            <c:spPr>
              <a:solidFill>
                <a:srgbClr val="EF3B6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BA9-412F-83FC-F406CBEAE29D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DB1435EF-EE03-4907-82F9-8A2AAA28A644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ABA9-412F-83FC-F406CBEAE29D}"/>
                </c:ext>
              </c:extLst>
            </c:dLbl>
            <c:dLbl>
              <c:idx val="1"/>
              <c:layout>
                <c:manualLayout>
                  <c:x val="-5.8472222222222224E-3"/>
                  <c:y val="7.2313848142065956E-2"/>
                </c:manualLayout>
              </c:layout>
              <c:tx>
                <c:rich>
                  <a:bodyPr rot="0" spcFirstLastPara="1" vertOverflow="ellipsis" vert="horz" wrap="square" lIns="0" tIns="0" rIns="0" bIns="0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F39FA750-B8A9-4025-93F2-9B1556B368F8}" type="CELLRANGE">
                      <a:rPr lang="en-US" altLang="zh-CN"/>
                      <a:pPr>
                        <a:defRPr/>
                      </a:pPr>
                      <a:t>[CELLRANGE]</a:t>
                    </a:fld>
                    <a:endParaRPr lang="zh-CN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0" tIns="0" rIns="0" bIns="0" anchor="ctr" anchorCtr="1"/>
                <a:lstStyle/>
                <a:p>
                  <a:pPr>
                    <a:defRPr sz="8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zh-CN"/>
                </a:p>
              </c:tx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204861111111112"/>
                      <c:h val="0.17433628826128267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ABA9-412F-83FC-F406CBEAE29D}"/>
                </c:ext>
              </c:extLst>
            </c:dLbl>
            <c:dLbl>
              <c:idx val="2"/>
              <c:layout>
                <c:manualLayout>
                  <c:x val="-5.4685016223404367E-17"/>
                  <c:y val="6.7796670489497196E-2"/>
                </c:manualLayout>
              </c:layout>
              <c:tx>
                <c:rich>
                  <a:bodyPr/>
                  <a:lstStyle/>
                  <a:p>
                    <a:fld id="{BAA24DD0-3F48-4B2F-98FD-AD0D07D4ED9F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ABA9-412F-83FC-F406CBEAE29D}"/>
                </c:ext>
              </c:extLst>
            </c:dLbl>
            <c:dLbl>
              <c:idx val="3"/>
              <c:layout>
                <c:manualLayout>
                  <c:x val="0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981243CA-7E9B-40D3-B012-E9F76D1D7697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ABA9-412F-83FC-F406CBEAE29D}"/>
                </c:ext>
              </c:extLst>
            </c:dLbl>
            <c:dLbl>
              <c:idx val="4"/>
              <c:layout>
                <c:manualLayout>
                  <c:x val="-1.0937003244680873E-16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675F9179-E101-441D-879F-FAF415EE3130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ABA9-412F-83FC-F406CBEAE29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ene21!$R$3:$R$4</c:f>
                <c:numCache>
                  <c:formatCode>General</c:formatCode>
                  <c:ptCount val="2"/>
                  <c:pt idx="0">
                    <c:v>4.5040060351347264E-2</c:v>
                  </c:pt>
                  <c:pt idx="1">
                    <c:v>3.3757251939751647E-2</c:v>
                  </c:pt>
                </c:numCache>
              </c:numRef>
            </c:plus>
            <c:minus>
              <c:numRef>
                <c:f>gene21!$R$3:$R$4</c:f>
                <c:numCache>
                  <c:formatCode>General</c:formatCode>
                  <c:ptCount val="2"/>
                  <c:pt idx="0">
                    <c:v>4.5040060351347264E-2</c:v>
                  </c:pt>
                  <c:pt idx="1">
                    <c:v>3.375725193975164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ene21!$P$3:$P$4</c:f>
              <c:strCache>
                <c:ptCount val="2"/>
                <c:pt idx="0">
                  <c:v>21-F1      </c:v>
                </c:pt>
                <c:pt idx="1">
                  <c:v>21-Y2      </c:v>
                </c:pt>
              </c:strCache>
            </c:strRef>
          </c:cat>
          <c:val>
            <c:numRef>
              <c:f>gene21!$Q$3:$Q$4</c:f>
              <c:numCache>
                <c:formatCode>General</c:formatCode>
                <c:ptCount val="2"/>
                <c:pt idx="0">
                  <c:v>1.0006773062044865</c:v>
                </c:pt>
                <c:pt idx="1">
                  <c:v>1.3444051511938218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2]root（模板）'!$S$10:$S$11</c15:f>
                <c15:dlblRangeCache>
                  <c:ptCount val="2"/>
                  <c:pt idx="1">
                    <c:v>**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7-ABA9-412F-83FC-F406CBEAE29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-481308512"/>
        <c:axId val="-355665552"/>
      </c:barChart>
      <c:catAx>
        <c:axId val="-481308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355665552"/>
        <c:crosses val="autoZero"/>
        <c:auto val="1"/>
        <c:lblAlgn val="ctr"/>
        <c:lblOffset val="100"/>
        <c:noMultiLvlLbl val="0"/>
      </c:catAx>
      <c:valAx>
        <c:axId val="-355665552"/>
        <c:scaling>
          <c:orientation val="minMax"/>
          <c:max val="2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481308512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290104166666669"/>
          <c:y val="0.13873855100835245"/>
          <c:w val="0.82336997624051467"/>
          <c:h val="0.807027721008693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ene23!$A$1</c:f>
              <c:strCache>
                <c:ptCount val="1"/>
                <c:pt idx="0">
                  <c:v>MVK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31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D05C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4FB-4210-AB31-5C5F84D5F277}"/>
              </c:ext>
            </c:extLst>
          </c:dPt>
          <c:dPt>
            <c:idx val="1"/>
            <c:invertIfNegative val="0"/>
            <c:bubble3D val="0"/>
            <c:spPr>
              <a:solidFill>
                <a:srgbClr val="EF3B6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4FB-4210-AB31-5C5F84D5F277}"/>
              </c:ext>
            </c:extLst>
          </c:dPt>
          <c:dLbls>
            <c:dLbl>
              <c:idx val="0"/>
              <c:layout>
                <c:manualLayout>
                  <c:x val="0.36303993055555556"/>
                  <c:y val="-0.34597892104664479"/>
                </c:manualLayout>
              </c:layout>
              <c:tx>
                <c:rich>
                  <a:bodyPr/>
                  <a:lstStyle/>
                  <a:p>
                    <a:fld id="{F4DB99F6-1B24-49E5-9265-90F99BFA8007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0547048611111111"/>
                      <c:h val="0.1261305610412154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84FB-4210-AB31-5C5F84D5F277}"/>
                </c:ext>
              </c:extLst>
            </c:dLbl>
            <c:dLbl>
              <c:idx val="1"/>
              <c:layout>
                <c:manualLayout>
                  <c:x val="-9.3134715703664175E-3"/>
                  <c:y val="5.4104128858391269E-2"/>
                </c:manualLayout>
              </c:layout>
              <c:tx>
                <c:rich>
                  <a:bodyPr rot="0" spcFirstLastPara="1" vertOverflow="ellipsis" vert="horz" wrap="square" lIns="0" tIns="0" rIns="0" bIns="0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endParaRPr lang="en-US" altLang="zh-CN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0" tIns="0" rIns="0" bIns="0" anchor="ctr" anchorCtr="1"/>
                <a:lstStyle/>
                <a:p>
                  <a:pPr>
                    <a:defRPr sz="8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zh-CN"/>
                </a:p>
              </c:tx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7511755039318264"/>
                      <c:h val="0.21075509131006104"/>
                    </c:manualLayout>
                  </c15:layout>
                  <c15:showDataLabelsRange val="1"/>
                </c:ext>
                <c:ext xmlns:c16="http://schemas.microsoft.com/office/drawing/2014/chart" uri="{C3380CC4-5D6E-409C-BE32-E72D297353CC}">
                  <c16:uniqueId val="{00000003-84FB-4210-AB31-5C5F84D5F277}"/>
                </c:ext>
              </c:extLst>
            </c:dLbl>
            <c:dLbl>
              <c:idx val="2"/>
              <c:layout>
                <c:manualLayout>
                  <c:x val="-5.4685016223404367E-17"/>
                  <c:y val="6.7796670489497196E-2"/>
                </c:manualLayout>
              </c:layout>
              <c:tx>
                <c:rich>
                  <a:bodyPr/>
                  <a:lstStyle/>
                  <a:p>
                    <a:fld id="{BAA24DD0-3F48-4B2F-98FD-AD0D07D4ED9F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84FB-4210-AB31-5C5F84D5F277}"/>
                </c:ext>
              </c:extLst>
            </c:dLbl>
            <c:dLbl>
              <c:idx val="3"/>
              <c:layout>
                <c:manualLayout>
                  <c:x val="0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981243CA-7E9B-40D3-B012-E9F76D1D7697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84FB-4210-AB31-5C5F84D5F277}"/>
                </c:ext>
              </c:extLst>
            </c:dLbl>
            <c:dLbl>
              <c:idx val="4"/>
              <c:layout>
                <c:manualLayout>
                  <c:x val="-1.0937003244680873E-16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675F9179-E101-441D-879F-FAF415EE3130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84FB-4210-AB31-5C5F84D5F27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ene23!$R$3:$R$4</c:f>
                <c:numCache>
                  <c:formatCode>General</c:formatCode>
                  <c:ptCount val="2"/>
                  <c:pt idx="0">
                    <c:v>0.13102750878015923</c:v>
                  </c:pt>
                  <c:pt idx="1">
                    <c:v>0.11510695171753203</c:v>
                  </c:pt>
                </c:numCache>
              </c:numRef>
            </c:plus>
            <c:minus>
              <c:numRef>
                <c:f>gene23!$R$3:$R$4</c:f>
                <c:numCache>
                  <c:formatCode>General</c:formatCode>
                  <c:ptCount val="2"/>
                  <c:pt idx="0">
                    <c:v>0.13102750878015923</c:v>
                  </c:pt>
                  <c:pt idx="1">
                    <c:v>0.115106951717532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ene23!$P$3:$P$4</c:f>
              <c:strCache>
                <c:ptCount val="2"/>
                <c:pt idx="0">
                  <c:v>23-F1      </c:v>
                </c:pt>
                <c:pt idx="1">
                  <c:v>23-Y2      </c:v>
                </c:pt>
              </c:strCache>
            </c:strRef>
          </c:cat>
          <c:val>
            <c:numRef>
              <c:f>gene23!$Q$3:$Q$4</c:f>
              <c:numCache>
                <c:formatCode>General</c:formatCode>
                <c:ptCount val="2"/>
                <c:pt idx="0">
                  <c:v>1.0054364124441553</c:v>
                </c:pt>
                <c:pt idx="1">
                  <c:v>2.9842582483912978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gene23!$S$11</c15:f>
                <c15:dlblRangeCache>
                  <c:ptCount val="1"/>
                  <c:pt idx="0">
                    <c:v>**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7-84FB-4210-AB31-5C5F84D5F27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-481308512"/>
        <c:axId val="-355665552"/>
      </c:barChart>
      <c:catAx>
        <c:axId val="-481308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355665552"/>
        <c:crosses val="autoZero"/>
        <c:auto val="1"/>
        <c:lblAlgn val="ctr"/>
        <c:lblOffset val="100"/>
        <c:noMultiLvlLbl val="0"/>
      </c:catAx>
      <c:valAx>
        <c:axId val="-355665552"/>
        <c:scaling>
          <c:orientation val="minMax"/>
          <c:max val="4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481308512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16722339640741"/>
          <c:y val="0.14249223051935631"/>
          <c:w val="0.82336997624051467"/>
          <c:h val="0.807027721008693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ene16!$A$1</c:f>
              <c:strCache>
                <c:ptCount val="1"/>
                <c:pt idx="0">
                  <c:v>FP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31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D05C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14F-4209-A191-8FE5925AB5D7}"/>
              </c:ext>
            </c:extLst>
          </c:dPt>
          <c:dPt>
            <c:idx val="1"/>
            <c:invertIfNegative val="0"/>
            <c:bubble3D val="0"/>
            <c:spPr>
              <a:solidFill>
                <a:srgbClr val="EF3B6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14F-4209-A191-8FE5925AB5D7}"/>
              </c:ext>
            </c:extLst>
          </c:dPt>
          <c:dLbls>
            <c:dLbl>
              <c:idx val="0"/>
              <c:layout>
                <c:manualLayout>
                  <c:x val="0.3100920138888888"/>
                  <c:y val="-0.64031500572737687"/>
                </c:manualLayout>
              </c:layout>
              <c:tx>
                <c:rich>
                  <a:bodyPr/>
                  <a:lstStyle/>
                  <a:p>
                    <a:fld id="{5F1C4798-491F-4E9B-AF57-CF9725D2B54A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"/>
                      <c:h val="0.11147098129056891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514F-4209-A191-8FE5925AB5D7}"/>
                </c:ext>
              </c:extLst>
            </c:dLbl>
            <c:dLbl>
              <c:idx val="1"/>
              <c:layout>
                <c:manualLayout>
                  <c:x val="-9.3133680555555556E-3"/>
                  <c:y val="-1.2139133327343191E-2"/>
                </c:manualLayout>
              </c:layout>
              <c:tx>
                <c:rich>
                  <a:bodyPr rot="0" spcFirstLastPara="1" vertOverflow="ellipsis" vert="horz" wrap="square" lIns="0" tIns="0" rIns="0" bIns="0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endParaRPr lang="en-US" altLang="zh-CN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0" tIns="0" rIns="0" bIns="0" anchor="ctr" anchorCtr="1"/>
                <a:lstStyle/>
                <a:p>
                  <a:pPr>
                    <a:defRPr sz="8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zh-CN"/>
                </a:p>
              </c:tx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7511755039318264"/>
                      <c:h val="0.21075509131006104"/>
                    </c:manualLayout>
                  </c15:layout>
                  <c15:showDataLabelsRange val="1"/>
                </c:ext>
                <c:ext xmlns:c16="http://schemas.microsoft.com/office/drawing/2014/chart" uri="{C3380CC4-5D6E-409C-BE32-E72D297353CC}">
                  <c16:uniqueId val="{00000003-514F-4209-A191-8FE5925AB5D7}"/>
                </c:ext>
              </c:extLst>
            </c:dLbl>
            <c:dLbl>
              <c:idx val="2"/>
              <c:layout>
                <c:manualLayout>
                  <c:x val="-5.4685016223404367E-17"/>
                  <c:y val="6.7796670489497196E-2"/>
                </c:manualLayout>
              </c:layout>
              <c:tx>
                <c:rich>
                  <a:bodyPr/>
                  <a:lstStyle/>
                  <a:p>
                    <a:fld id="{BAA24DD0-3F48-4B2F-98FD-AD0D07D4ED9F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514F-4209-A191-8FE5925AB5D7}"/>
                </c:ext>
              </c:extLst>
            </c:dLbl>
            <c:dLbl>
              <c:idx val="3"/>
              <c:layout>
                <c:manualLayout>
                  <c:x val="0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981243CA-7E9B-40D3-B012-E9F76D1D7697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514F-4209-A191-8FE5925AB5D7}"/>
                </c:ext>
              </c:extLst>
            </c:dLbl>
            <c:dLbl>
              <c:idx val="4"/>
              <c:layout>
                <c:manualLayout>
                  <c:x val="-1.0937003244680873E-16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675F9179-E101-441D-879F-FAF415EE3130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514F-4209-A191-8FE5925AB5D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ene16!$R$3:$R$4</c:f>
                <c:numCache>
                  <c:formatCode>General</c:formatCode>
                  <c:ptCount val="2"/>
                  <c:pt idx="0">
                    <c:v>2.5471983522332761E-2</c:v>
                  </c:pt>
                  <c:pt idx="1">
                    <c:v>3.6227219803171189</c:v>
                  </c:pt>
                </c:numCache>
              </c:numRef>
            </c:plus>
            <c:minus>
              <c:numRef>
                <c:f>gene16!$R$3:$R$4</c:f>
                <c:numCache>
                  <c:formatCode>General</c:formatCode>
                  <c:ptCount val="2"/>
                  <c:pt idx="0">
                    <c:v>2.5471983522332761E-2</c:v>
                  </c:pt>
                  <c:pt idx="1">
                    <c:v>3.62272198031711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ene16!$P$3:$P$4</c:f>
              <c:strCache>
                <c:ptCount val="2"/>
                <c:pt idx="0">
                  <c:v>16-F1      </c:v>
                </c:pt>
                <c:pt idx="1">
                  <c:v>16-Y2</c:v>
                </c:pt>
              </c:strCache>
            </c:strRef>
          </c:cat>
          <c:val>
            <c:numRef>
              <c:f>gene16!$Q$3:$Q$4</c:f>
              <c:numCache>
                <c:formatCode>General</c:formatCode>
                <c:ptCount val="2"/>
                <c:pt idx="0">
                  <c:v>1.000486498118212</c:v>
                </c:pt>
                <c:pt idx="1">
                  <c:v>19.388013161809045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gene16!$S$11</c15:f>
                <c15:dlblRangeCache>
                  <c:ptCount val="1"/>
                  <c:pt idx="0">
                    <c:v>*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7-514F-4209-A191-8FE5925AB5D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-481308512"/>
        <c:axId val="-355665552"/>
      </c:barChart>
      <c:catAx>
        <c:axId val="-481308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355665552"/>
        <c:crosses val="autoZero"/>
        <c:auto val="1"/>
        <c:lblAlgn val="ctr"/>
        <c:lblOffset val="100"/>
        <c:noMultiLvlLbl val="0"/>
      </c:catAx>
      <c:valAx>
        <c:axId val="-355665552"/>
        <c:scaling>
          <c:orientation val="minMax"/>
          <c:max val="2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481308512"/>
        <c:crosses val="autoZero"/>
        <c:crossBetween val="between"/>
        <c:majorUnit val="5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16722339640741"/>
          <c:y val="0.14249223051935631"/>
          <c:w val="0.82336997624051467"/>
          <c:h val="0.807027721008693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ene4!$A$1</c:f>
              <c:strCache>
                <c:ptCount val="1"/>
                <c:pt idx="0">
                  <c:v>HMGCR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31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D05C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961-422A-B391-E02D40F12532}"/>
              </c:ext>
            </c:extLst>
          </c:dPt>
          <c:dPt>
            <c:idx val="1"/>
            <c:invertIfNegative val="0"/>
            <c:bubble3D val="0"/>
            <c:spPr>
              <a:solidFill>
                <a:srgbClr val="EF3B69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961-422A-B391-E02D40F12532}"/>
              </c:ext>
            </c:extLst>
          </c:dPt>
          <c:dLbls>
            <c:dLbl>
              <c:idx val="0"/>
              <c:layout>
                <c:manualLayout>
                  <c:x val="0.3526371527777778"/>
                  <c:y val="-0.39345889189926081"/>
                </c:manualLayout>
              </c:layout>
              <c:tx>
                <c:rich>
                  <a:bodyPr/>
                  <a:lstStyle/>
                  <a:p>
                    <a:fld id="{DF5AF50D-5289-444A-BA33-7D0AF0DF4AD3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5427805862579415"/>
                      <c:h val="0.26483456918184428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1961-422A-B391-E02D40F12532}"/>
                </c:ext>
              </c:extLst>
            </c:dLbl>
            <c:dLbl>
              <c:idx val="1"/>
              <c:layout>
                <c:manualLayout>
                  <c:x val="-9.2029064732720035E-3"/>
                  <c:y val="-0.1437324639823114"/>
                </c:manualLayout>
              </c:layout>
              <c:tx>
                <c:rich>
                  <a:bodyPr rot="0" spcFirstLastPara="1" vertOverflow="ellipsis" vert="horz" wrap="square" lIns="0" tIns="0" rIns="0" bIns="0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endParaRPr lang="en-US" altLang="zh-CN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0" tIns="0" rIns="0" bIns="0" anchor="ctr" anchorCtr="1"/>
                <a:lstStyle/>
                <a:p>
                  <a:pPr>
                    <a:defRPr sz="8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zh-CN"/>
                </a:p>
              </c:tx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7511755039318264"/>
                      <c:h val="0.21075509131006104"/>
                    </c:manualLayout>
                  </c15:layout>
                  <c15:showDataLabelsRange val="1"/>
                </c:ext>
                <c:ext xmlns:c16="http://schemas.microsoft.com/office/drawing/2014/chart" uri="{C3380CC4-5D6E-409C-BE32-E72D297353CC}">
                  <c16:uniqueId val="{00000003-1961-422A-B391-E02D40F12532}"/>
                </c:ext>
              </c:extLst>
            </c:dLbl>
            <c:dLbl>
              <c:idx val="2"/>
              <c:layout>
                <c:manualLayout>
                  <c:x val="-5.4685016223404367E-17"/>
                  <c:y val="6.7796670489497196E-2"/>
                </c:manualLayout>
              </c:layout>
              <c:tx>
                <c:rich>
                  <a:bodyPr/>
                  <a:lstStyle/>
                  <a:p>
                    <a:fld id="{BAA24DD0-3F48-4B2F-98FD-AD0D07D4ED9F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1961-422A-B391-E02D40F12532}"/>
                </c:ext>
              </c:extLst>
            </c:dLbl>
            <c:dLbl>
              <c:idx val="3"/>
              <c:layout>
                <c:manualLayout>
                  <c:x val="0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981243CA-7E9B-40D3-B012-E9F76D1D7697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1961-422A-B391-E02D40F12532}"/>
                </c:ext>
              </c:extLst>
            </c:dLbl>
            <c:dLbl>
              <c:idx val="4"/>
              <c:layout>
                <c:manualLayout>
                  <c:x val="-1.0937003244680873E-16"/>
                  <c:y val="5.6497225407914416E-2"/>
                </c:manualLayout>
              </c:layout>
              <c:tx>
                <c:rich>
                  <a:bodyPr/>
                  <a:lstStyle/>
                  <a:p>
                    <a:fld id="{675F9179-E101-441D-879F-FAF415EE3130}" type="CELLRANGE">
                      <a:rPr lang="en-US" altLang="zh-CN"/>
                      <a:pPr/>
                      <a:t>[CELLRANGE]</a:t>
                    </a:fld>
                    <a:endParaRPr lang="zh-CN" alt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1961-422A-B391-E02D40F1253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ene4!$R$3:$R$4</c:f>
                <c:numCache>
                  <c:formatCode>General</c:formatCode>
                  <c:ptCount val="2"/>
                  <c:pt idx="0">
                    <c:v>0.45287467243110585</c:v>
                  </c:pt>
                  <c:pt idx="1">
                    <c:v>0.83055340071565498</c:v>
                  </c:pt>
                </c:numCache>
              </c:numRef>
            </c:plus>
            <c:minus>
              <c:numRef>
                <c:f>gene4!$R$3:$R$4</c:f>
                <c:numCache>
                  <c:formatCode>General</c:formatCode>
                  <c:ptCount val="2"/>
                  <c:pt idx="0">
                    <c:v>0.45287467243110585</c:v>
                  </c:pt>
                  <c:pt idx="1">
                    <c:v>0.830553400715654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ene4!$P$3:$P$4</c:f>
              <c:strCache>
                <c:ptCount val="2"/>
                <c:pt idx="0">
                  <c:v>4-F1       </c:v>
                </c:pt>
                <c:pt idx="1">
                  <c:v>4-Y2       </c:v>
                </c:pt>
              </c:strCache>
            </c:strRef>
          </c:cat>
          <c:val>
            <c:numRef>
              <c:f>gene4!$Q$3:$Q$4</c:f>
              <c:numCache>
                <c:formatCode>General</c:formatCode>
                <c:ptCount val="2"/>
                <c:pt idx="0">
                  <c:v>1.2340219709866991</c:v>
                </c:pt>
                <c:pt idx="1">
                  <c:v>4.3344942012011005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gene4!$S$11</c15:f>
                <c15:dlblRangeCache>
                  <c:ptCount val="1"/>
                  <c:pt idx="0">
                    <c:v>*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7-1961-422A-B391-E02D40F1253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-481308512"/>
        <c:axId val="-355665552"/>
      </c:barChart>
      <c:catAx>
        <c:axId val="-481308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355665552"/>
        <c:crosses val="autoZero"/>
        <c:auto val="1"/>
        <c:lblAlgn val="ctr"/>
        <c:lblOffset val="100"/>
        <c:noMultiLvlLbl val="0"/>
      </c:catAx>
      <c:valAx>
        <c:axId val="-355665552"/>
        <c:scaling>
          <c:orientation val="minMax"/>
          <c:max val="6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 cmpd="sng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481308512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8228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7354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891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408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3968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1462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5898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2683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2108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926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2571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79D5D-C784-4464-9055-DCE738E9312F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9C4A1E-B8B1-4317-BB2A-9C6BDBC18C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2818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BF166E9F-00E3-7B56-8E37-FA603E120E7A}"/>
              </a:ext>
            </a:extLst>
          </p:cNvPr>
          <p:cNvGrpSpPr/>
          <p:nvPr/>
        </p:nvGrpSpPr>
        <p:grpSpPr>
          <a:xfrm>
            <a:off x="1599426" y="1152659"/>
            <a:ext cx="3684222" cy="2461455"/>
            <a:chOff x="1599426" y="1152659"/>
            <a:chExt cx="3684222" cy="2461455"/>
          </a:xfrm>
        </p:grpSpPr>
        <p:graphicFrame>
          <p:nvGraphicFramePr>
            <p:cNvPr id="29" name="图表 28">
              <a:extLst>
                <a:ext uri="{FF2B5EF4-FFF2-40B4-BE49-F238E27FC236}">
                  <a16:creationId xmlns:a16="http://schemas.microsoft.com/office/drawing/2014/main" id="{0A3F8C05-F39A-8E07-2EE7-60CB4F3BAA3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2335780"/>
                </p:ext>
              </p:extLst>
            </p:nvPr>
          </p:nvGraphicFramePr>
          <p:xfrm>
            <a:off x="4101328" y="2565148"/>
            <a:ext cx="637967" cy="10461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0" name="图表 29">
              <a:extLst>
                <a:ext uri="{FF2B5EF4-FFF2-40B4-BE49-F238E27FC236}">
                  <a16:creationId xmlns:a16="http://schemas.microsoft.com/office/drawing/2014/main" id="{C39D74EC-0D31-FB25-13E6-DEBA8A4B757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65978164"/>
                </p:ext>
              </p:extLst>
            </p:nvPr>
          </p:nvGraphicFramePr>
          <p:xfrm>
            <a:off x="1813144" y="1322210"/>
            <a:ext cx="576000" cy="1047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31" name="图表 30">
              <a:extLst>
                <a:ext uri="{FF2B5EF4-FFF2-40B4-BE49-F238E27FC236}">
                  <a16:creationId xmlns:a16="http://schemas.microsoft.com/office/drawing/2014/main" id="{250C820B-ADBB-A65F-2D26-9DBE29037C3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59952056"/>
                </p:ext>
              </p:extLst>
            </p:nvPr>
          </p:nvGraphicFramePr>
          <p:xfrm>
            <a:off x="2596528" y="1311503"/>
            <a:ext cx="576000" cy="1047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32" name="图表 31">
              <a:extLst>
                <a:ext uri="{FF2B5EF4-FFF2-40B4-BE49-F238E27FC236}">
                  <a16:creationId xmlns:a16="http://schemas.microsoft.com/office/drawing/2014/main" id="{E9FF3505-44CD-B5F1-F1BD-B0B23953694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0679497"/>
                </p:ext>
              </p:extLst>
            </p:nvPr>
          </p:nvGraphicFramePr>
          <p:xfrm>
            <a:off x="4163295" y="1316340"/>
            <a:ext cx="576000" cy="10461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33" name="图表 32">
              <a:extLst>
                <a:ext uri="{FF2B5EF4-FFF2-40B4-BE49-F238E27FC236}">
                  <a16:creationId xmlns:a16="http://schemas.microsoft.com/office/drawing/2014/main" id="{A42FBDA3-6936-239F-0ABB-499962A3A8A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57984826"/>
                </p:ext>
              </p:extLst>
            </p:nvPr>
          </p:nvGraphicFramePr>
          <p:xfrm>
            <a:off x="1813144" y="2565148"/>
            <a:ext cx="576000" cy="10461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34" name="图表 33">
              <a:extLst>
                <a:ext uri="{FF2B5EF4-FFF2-40B4-BE49-F238E27FC236}">
                  <a16:creationId xmlns:a16="http://schemas.microsoft.com/office/drawing/2014/main" id="{F9158425-2643-DD44-ED1B-0B4691E1E71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12124887"/>
                </p:ext>
              </p:extLst>
            </p:nvPr>
          </p:nvGraphicFramePr>
          <p:xfrm>
            <a:off x="3379912" y="2565148"/>
            <a:ext cx="576000" cy="10461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9580B0BC-5357-EB66-82D3-E009C575992F}"/>
                </a:ext>
              </a:extLst>
            </p:cNvPr>
            <p:cNvSpPr txBox="1"/>
            <p:nvPr/>
          </p:nvSpPr>
          <p:spPr>
            <a:xfrm>
              <a:off x="1877598" y="1210812"/>
              <a:ext cx="57600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j4C267T4</a:t>
              </a:r>
            </a:p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DXS)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5DB5A9F8-31B4-164A-2EE3-4DE6A7205100}"/>
                </a:ext>
              </a:extLst>
            </p:cNvPr>
            <p:cNvSpPr txBox="1"/>
            <p:nvPr/>
          </p:nvSpPr>
          <p:spPr>
            <a:xfrm>
              <a:off x="2674997" y="1210812"/>
              <a:ext cx="57600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j5A124T67</a:t>
              </a:r>
            </a:p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DXR)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14E6A253-A02D-816C-BCF2-9139FD9ACBF0}"/>
                </a:ext>
              </a:extLst>
            </p:cNvPr>
            <p:cNvSpPr txBox="1"/>
            <p:nvPr/>
          </p:nvSpPr>
          <p:spPr>
            <a:xfrm>
              <a:off x="4195134" y="1210812"/>
              <a:ext cx="64989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j3A1009G50</a:t>
              </a:r>
            </a:p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GGPPS)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51F8DF53-C839-EBF6-F6D0-567A26E46C76}"/>
                </a:ext>
              </a:extLst>
            </p:cNvPr>
            <p:cNvSpPr txBox="1"/>
            <p:nvPr/>
          </p:nvSpPr>
          <p:spPr>
            <a:xfrm>
              <a:off x="1877598" y="2458320"/>
              <a:ext cx="57600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j8C240G7</a:t>
              </a:r>
            </a:p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HMGCS)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C4F1B0AE-DB15-A215-B8D5-BA7C2133338E}"/>
                </a:ext>
              </a:extLst>
            </p:cNvPr>
            <p:cNvSpPr txBox="1"/>
            <p:nvPr/>
          </p:nvSpPr>
          <p:spPr>
            <a:xfrm>
              <a:off x="2674997" y="2458320"/>
              <a:ext cx="57600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j4A243T61</a:t>
              </a:r>
            </a:p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HMGCR)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83E84829-EDD5-AC8D-5756-455114B00C02}"/>
                </a:ext>
              </a:extLst>
            </p:cNvPr>
            <p:cNvSpPr txBox="1"/>
            <p:nvPr/>
          </p:nvSpPr>
          <p:spPr>
            <a:xfrm>
              <a:off x="3473717" y="2458320"/>
              <a:ext cx="57600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j9A25G19</a:t>
              </a:r>
            </a:p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MVK)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F70027D6-61AC-B4DB-6D24-7379364E4819}"/>
                </a:ext>
              </a:extLst>
            </p:cNvPr>
            <p:cNvSpPr txBox="1"/>
            <p:nvPr/>
          </p:nvSpPr>
          <p:spPr>
            <a:xfrm>
              <a:off x="3473717" y="1210812"/>
              <a:ext cx="57600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j2A447T56</a:t>
              </a:r>
            </a:p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FPS)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571C318C-6283-9D07-D31C-786336202AA7}"/>
                </a:ext>
              </a:extLst>
            </p:cNvPr>
            <p:cNvSpPr txBox="1"/>
            <p:nvPr/>
          </p:nvSpPr>
          <p:spPr>
            <a:xfrm>
              <a:off x="4312592" y="2458320"/>
              <a:ext cx="532432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j5C695T2</a:t>
              </a:r>
            </a:p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AFS1)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3" name="图表 42">
              <a:extLst>
                <a:ext uri="{FF2B5EF4-FFF2-40B4-BE49-F238E27FC236}">
                  <a16:creationId xmlns:a16="http://schemas.microsoft.com/office/drawing/2014/main" id="{C9442F89-D9DE-045A-6D53-892EEE164E2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44394057"/>
                </p:ext>
              </p:extLst>
            </p:nvPr>
          </p:nvGraphicFramePr>
          <p:xfrm>
            <a:off x="3328300" y="1315382"/>
            <a:ext cx="637200" cy="1047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44" name="图表 43">
              <a:extLst>
                <a:ext uri="{FF2B5EF4-FFF2-40B4-BE49-F238E27FC236}">
                  <a16:creationId xmlns:a16="http://schemas.microsoft.com/office/drawing/2014/main" id="{564065CF-84B4-784A-7702-6F2A9C9671E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36622562"/>
                </p:ext>
              </p:extLst>
            </p:nvPr>
          </p:nvGraphicFramePr>
          <p:xfrm>
            <a:off x="2596528" y="2565148"/>
            <a:ext cx="576000" cy="104896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id="{7DA96DF6-106D-393A-0D7F-26F1E9F8BDD5}"/>
                </a:ext>
              </a:extLst>
            </p:cNvPr>
            <p:cNvGrpSpPr/>
            <p:nvPr/>
          </p:nvGrpSpPr>
          <p:grpSpPr>
            <a:xfrm>
              <a:off x="4937090" y="1333922"/>
              <a:ext cx="346558" cy="262218"/>
              <a:chOff x="3899382" y="4706962"/>
              <a:chExt cx="346558" cy="262218"/>
            </a:xfrm>
          </p:grpSpPr>
          <p:sp>
            <p:nvSpPr>
              <p:cNvPr id="46" name="矩形 45">
                <a:extLst>
                  <a:ext uri="{FF2B5EF4-FFF2-40B4-BE49-F238E27FC236}">
                    <a16:creationId xmlns:a16="http://schemas.microsoft.com/office/drawing/2014/main" id="{191670D3-2AA8-340B-4EB4-A79158D51E03}"/>
                  </a:ext>
                </a:extLst>
              </p:cNvPr>
              <p:cNvSpPr/>
              <p:nvPr/>
            </p:nvSpPr>
            <p:spPr>
              <a:xfrm>
                <a:off x="3899382" y="4866225"/>
                <a:ext cx="122400" cy="82800"/>
              </a:xfrm>
              <a:prstGeom prst="rect">
                <a:avLst/>
              </a:prstGeom>
              <a:solidFill>
                <a:srgbClr val="EF3B6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89B3C951-2057-1C99-F94B-1FBE483B5A04}"/>
                  </a:ext>
                </a:extLst>
              </p:cNvPr>
              <p:cNvSpPr/>
              <p:nvPr/>
            </p:nvSpPr>
            <p:spPr>
              <a:xfrm>
                <a:off x="3899382" y="4726523"/>
                <a:ext cx="121128" cy="83990"/>
              </a:xfrm>
              <a:prstGeom prst="rect">
                <a:avLst/>
              </a:prstGeom>
              <a:solidFill>
                <a:srgbClr val="FFD05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F11AF7D3-A9CE-4AD9-A9DC-86F4824D4C2E}"/>
                  </a:ext>
                </a:extLst>
              </p:cNvPr>
              <p:cNvSpPr txBox="1"/>
              <p:nvPr/>
            </p:nvSpPr>
            <p:spPr>
              <a:xfrm>
                <a:off x="4020510" y="4706962"/>
                <a:ext cx="225429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5D3F036A-C997-9245-D3E1-C0833384C2E5}"/>
                  </a:ext>
                </a:extLst>
              </p:cNvPr>
              <p:cNvSpPr txBox="1"/>
              <p:nvPr/>
            </p:nvSpPr>
            <p:spPr>
              <a:xfrm>
                <a:off x="4020510" y="4846069"/>
                <a:ext cx="22543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Y2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B8D903C4-35AA-CEE3-BB5F-79EFCF11F95C}"/>
                </a:ext>
              </a:extLst>
            </p:cNvPr>
            <p:cNvSpPr txBox="1"/>
            <p:nvPr/>
          </p:nvSpPr>
          <p:spPr>
            <a:xfrm rot="10800000">
              <a:off x="1599426" y="1152659"/>
              <a:ext cx="153888" cy="1147620"/>
            </a:xfrm>
            <a:prstGeom prst="rect">
              <a:avLst/>
            </a:prstGeom>
            <a:noFill/>
          </p:spPr>
          <p:txBody>
            <a:bodyPr vert="eaVert" wrap="square" lIns="0" tIns="0" rIns="0" bIns="0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D11CC45C-69A4-C415-4DC4-DC9DC27E5ED1}"/>
                </a:ext>
              </a:extLst>
            </p:cNvPr>
            <p:cNvSpPr txBox="1"/>
            <p:nvPr/>
          </p:nvSpPr>
          <p:spPr>
            <a:xfrm rot="10800000">
              <a:off x="1604732" y="2463690"/>
              <a:ext cx="153888" cy="1147620"/>
            </a:xfrm>
            <a:prstGeom prst="rect">
              <a:avLst/>
            </a:prstGeom>
            <a:noFill/>
          </p:spPr>
          <p:txBody>
            <a:bodyPr vert="eaVert" wrap="square" lIns="0" tIns="0" rIns="0" bIns="0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EF8537B6-486A-BB1E-F5C2-E0F4B0E0B8BA}"/>
              </a:ext>
            </a:extLst>
          </p:cNvPr>
          <p:cNvSpPr txBox="1"/>
          <p:nvPr/>
        </p:nvSpPr>
        <p:spPr>
          <a:xfrm>
            <a:off x="566055" y="3705828"/>
            <a:ext cx="5760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zh-CN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GB" altLang="zh-CN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analysis of candidate genes involved in terpenoid biosynthetic pathway using </a:t>
            </a:r>
            <a:r>
              <a:rPr lang="en-GB" altLang="zh-CN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GB" altLang="zh-CN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-PCR. The ubiquitin gene was used as an internal reference. The values are presented as mean ± SD (n = 3). Significant differences between ‘Yujin2’ and ‘Fengjin1’ are marked with asterisks (**p &lt; 0.01, * p &lt; 0.05, Student’ s t-test). The full names of the abbreviations (gene names) are provided in Supplementary Table 14.</a:t>
            </a:r>
            <a:endParaRPr lang="zh-CN" altLang="zh-CN" sz="1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956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</TotalTime>
  <Words>162</Words>
  <Application>Microsoft Office PowerPoint</Application>
  <PresentationFormat>A4 纸张(210x297 毫米)</PresentationFormat>
  <Paragraphs>5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禹 新杰</dc:creator>
  <cp:lastModifiedBy>YuJJ</cp:lastModifiedBy>
  <cp:revision>25</cp:revision>
  <dcterms:created xsi:type="dcterms:W3CDTF">2022-06-18T10:42:13Z</dcterms:created>
  <dcterms:modified xsi:type="dcterms:W3CDTF">2022-08-18T07:15:49Z</dcterms:modified>
</cp:coreProperties>
</file>